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0" d="100"/>
          <a:sy n="50" d="100"/>
        </p:scale>
        <p:origin x="1614" y="5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6F988-4A1D-4AFF-9D1D-62AA1E7A9C92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7A00-3959-42CF-816D-688C823F82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469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6F988-4A1D-4AFF-9D1D-62AA1E7A9C92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7A00-3959-42CF-816D-688C823F82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0752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6F988-4A1D-4AFF-9D1D-62AA1E7A9C92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7A00-3959-42CF-816D-688C823F82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1420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6F988-4A1D-4AFF-9D1D-62AA1E7A9C92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7A00-3959-42CF-816D-688C823F82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3614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6F988-4A1D-4AFF-9D1D-62AA1E7A9C92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7A00-3959-42CF-816D-688C823F82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3632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6F988-4A1D-4AFF-9D1D-62AA1E7A9C92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7A00-3959-42CF-816D-688C823F82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0870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6F988-4A1D-4AFF-9D1D-62AA1E7A9C92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7A00-3959-42CF-816D-688C823F82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2969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6F988-4A1D-4AFF-9D1D-62AA1E7A9C92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7A00-3959-42CF-816D-688C823F82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2124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6F988-4A1D-4AFF-9D1D-62AA1E7A9C92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7A00-3959-42CF-816D-688C823F82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9989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6F988-4A1D-4AFF-9D1D-62AA1E7A9C92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7A00-3959-42CF-816D-688C823F82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7211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6F988-4A1D-4AFF-9D1D-62AA1E7A9C92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7A00-3959-42CF-816D-688C823F82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4531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D6F988-4A1D-4AFF-9D1D-62AA1E7A9C92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517A00-3959-42CF-816D-688C823F82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6484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文本框 44">
            <a:extLst>
              <a:ext uri="{FF2B5EF4-FFF2-40B4-BE49-F238E27FC236}">
                <a16:creationId xmlns:a16="http://schemas.microsoft.com/office/drawing/2014/main" id="{F9EDDD60-4ED1-5CE6-8A1D-3275EBF31AE3}"/>
              </a:ext>
            </a:extLst>
          </p:cNvPr>
          <p:cNvSpPr txBox="1"/>
          <p:nvPr/>
        </p:nvSpPr>
        <p:spPr>
          <a:xfrm>
            <a:off x="744284" y="7909205"/>
            <a:ext cx="516159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Figure S1. </a:t>
            </a:r>
            <a:r>
              <a:rPr lang="en-US" altLang="zh-CN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eq Logos of 10 MEME-motifs for the identified </a:t>
            </a:r>
            <a:r>
              <a:rPr lang="en-US" altLang="zh-CN" sz="16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hCYP</a:t>
            </a:r>
            <a:r>
              <a:rPr lang="en-US" altLang="zh-CN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proteins.</a:t>
            </a:r>
            <a:endParaRPr lang="zh-CN" altLang="en-US" sz="1600" dirty="0"/>
          </a:p>
        </p:txBody>
      </p: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ED409F1C-851F-98C6-99C7-C6F882127B9A}"/>
              </a:ext>
            </a:extLst>
          </p:cNvPr>
          <p:cNvGrpSpPr/>
          <p:nvPr/>
        </p:nvGrpSpPr>
        <p:grpSpPr>
          <a:xfrm>
            <a:off x="1468848" y="1181178"/>
            <a:ext cx="3491603" cy="6308793"/>
            <a:chOff x="1468848" y="1181178"/>
            <a:chExt cx="3491603" cy="6308793"/>
          </a:xfrm>
        </p:grpSpPr>
        <p:grpSp>
          <p:nvGrpSpPr>
            <p:cNvPr id="44" name="组合 43">
              <a:extLst>
                <a:ext uri="{FF2B5EF4-FFF2-40B4-BE49-F238E27FC236}">
                  <a16:creationId xmlns:a16="http://schemas.microsoft.com/office/drawing/2014/main" id="{FCC01E02-9F52-0DE8-DAA5-76232E21E050}"/>
                </a:ext>
              </a:extLst>
            </p:cNvPr>
            <p:cNvGrpSpPr/>
            <p:nvPr/>
          </p:nvGrpSpPr>
          <p:grpSpPr>
            <a:xfrm>
              <a:off x="1468848" y="1328264"/>
              <a:ext cx="887310" cy="6030122"/>
              <a:chOff x="1468848" y="1328264"/>
              <a:chExt cx="887310" cy="6030122"/>
            </a:xfrm>
          </p:grpSpPr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935CD70A-0103-1CE9-F78E-1A86C321EA30}"/>
                  </a:ext>
                </a:extLst>
              </p:cNvPr>
              <p:cNvSpPr txBox="1"/>
              <p:nvPr/>
            </p:nvSpPr>
            <p:spPr>
              <a:xfrm>
                <a:off x="1468848" y="1328264"/>
                <a:ext cx="88731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1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7985E973-2C11-45B0-B403-9F9E8DD883FF}"/>
                  </a:ext>
                </a:extLst>
              </p:cNvPr>
              <p:cNvSpPr txBox="1"/>
              <p:nvPr/>
            </p:nvSpPr>
            <p:spPr>
              <a:xfrm>
                <a:off x="1468848" y="1955131"/>
                <a:ext cx="88731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2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B9A2F2AB-C0CB-A752-D507-6ADA7AB09D11}"/>
                  </a:ext>
                </a:extLst>
              </p:cNvPr>
              <p:cNvSpPr txBox="1"/>
              <p:nvPr/>
            </p:nvSpPr>
            <p:spPr>
              <a:xfrm>
                <a:off x="1468848" y="2592121"/>
                <a:ext cx="88731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3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9AF96624-D6FB-628E-E67E-B8AF0D347E44}"/>
                  </a:ext>
                </a:extLst>
              </p:cNvPr>
              <p:cNvSpPr txBox="1"/>
              <p:nvPr/>
            </p:nvSpPr>
            <p:spPr>
              <a:xfrm>
                <a:off x="1468848" y="3217835"/>
                <a:ext cx="88731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4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0BB5A7A5-3F03-0E47-B8BF-4077DD51A628}"/>
                  </a:ext>
                </a:extLst>
              </p:cNvPr>
              <p:cNvSpPr txBox="1"/>
              <p:nvPr/>
            </p:nvSpPr>
            <p:spPr>
              <a:xfrm>
                <a:off x="1468848" y="3852080"/>
                <a:ext cx="88731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5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8882FDBE-840A-A405-300F-BD42AACC5606}"/>
                  </a:ext>
                </a:extLst>
              </p:cNvPr>
              <p:cNvSpPr txBox="1"/>
              <p:nvPr/>
            </p:nvSpPr>
            <p:spPr>
              <a:xfrm>
                <a:off x="1468848" y="4479560"/>
                <a:ext cx="88731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6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1">
                <a:extLst>
                  <a:ext uri="{FF2B5EF4-FFF2-40B4-BE49-F238E27FC236}">
                    <a16:creationId xmlns:a16="http://schemas.microsoft.com/office/drawing/2014/main" id="{935CD70A-0103-1CE9-F78E-1A86C321EA30}"/>
                  </a:ext>
                </a:extLst>
              </p:cNvPr>
              <p:cNvSpPr txBox="1"/>
              <p:nvPr/>
            </p:nvSpPr>
            <p:spPr>
              <a:xfrm>
                <a:off x="1468848" y="5108359"/>
                <a:ext cx="88731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7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文本框 31">
                <a:extLst>
                  <a:ext uri="{FF2B5EF4-FFF2-40B4-BE49-F238E27FC236}">
                    <a16:creationId xmlns:a16="http://schemas.microsoft.com/office/drawing/2014/main" id="{935CD70A-0103-1CE9-F78E-1A86C321EA30}"/>
                  </a:ext>
                </a:extLst>
              </p:cNvPr>
              <p:cNvSpPr txBox="1"/>
              <p:nvPr/>
            </p:nvSpPr>
            <p:spPr>
              <a:xfrm>
                <a:off x="1468848" y="5746545"/>
                <a:ext cx="88731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8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文本框 31">
                <a:extLst>
                  <a:ext uri="{FF2B5EF4-FFF2-40B4-BE49-F238E27FC236}">
                    <a16:creationId xmlns:a16="http://schemas.microsoft.com/office/drawing/2014/main" id="{935CD70A-0103-1CE9-F78E-1A86C321EA30}"/>
                  </a:ext>
                </a:extLst>
              </p:cNvPr>
              <p:cNvSpPr txBox="1"/>
              <p:nvPr/>
            </p:nvSpPr>
            <p:spPr>
              <a:xfrm>
                <a:off x="1468848" y="6387882"/>
                <a:ext cx="88731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9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31">
                <a:extLst>
                  <a:ext uri="{FF2B5EF4-FFF2-40B4-BE49-F238E27FC236}">
                    <a16:creationId xmlns:a16="http://schemas.microsoft.com/office/drawing/2014/main" id="{935CD70A-0103-1CE9-F78E-1A86C321EA30}"/>
                  </a:ext>
                </a:extLst>
              </p:cNvPr>
              <p:cNvSpPr txBox="1"/>
              <p:nvPr/>
            </p:nvSpPr>
            <p:spPr>
              <a:xfrm>
                <a:off x="1468848" y="7019832"/>
                <a:ext cx="88731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10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238ECD2E-6DA6-99AE-974B-639E621E151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2382" y="1181178"/>
              <a:ext cx="2508069" cy="624363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5D0E253B-C5E9-6A2E-36C0-1B20507E7A8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2382" y="1811843"/>
              <a:ext cx="1939391" cy="630731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2EFE9B29-7CD3-EF5F-C9D0-97704B206A9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2382" y="2438776"/>
              <a:ext cx="2196828" cy="630730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AE098CD8-EA24-E3EC-0952-FF3F989C110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42693" y="3071396"/>
              <a:ext cx="1949080" cy="633882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59ECE708-ABFD-7588-9C31-53ED24FC914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2382" y="3718071"/>
              <a:ext cx="1587046" cy="624620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314B3A25-AF9D-3FE1-CEE6-D99EADA2BDA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42693" y="4324858"/>
              <a:ext cx="1764779" cy="628142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E8FA2AC1-E8AC-4096-1EB4-CA59F46FFC8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2382" y="4939068"/>
              <a:ext cx="2206517" cy="633512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66BA707D-5AC3-D502-1F2E-B17054A3664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2382" y="5567210"/>
              <a:ext cx="1508968" cy="664127"/>
            </a:xfrm>
            <a:prstGeom prst="rect">
              <a:avLst/>
            </a:prstGeom>
          </p:spPr>
        </p:pic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A6336FE3-5221-80C1-E55C-D5AF95106DF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2382" y="6219538"/>
              <a:ext cx="1440249" cy="633882"/>
            </a:xfrm>
            <a:prstGeom prst="rect">
              <a:avLst/>
            </a:prstGeom>
          </p:spPr>
        </p:pic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16FD1427-3179-5254-7015-D33D1BE8C0D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42693" y="6856089"/>
              <a:ext cx="1949080" cy="63388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5936139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4</TotalTime>
  <Words>34</Words>
  <Application>Microsoft Office PowerPoint</Application>
  <PresentationFormat>A4 纸张(210x297 毫米)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鲲 张</dc:creator>
  <cp:lastModifiedBy>鲲 张</cp:lastModifiedBy>
  <cp:revision>4</cp:revision>
  <dcterms:created xsi:type="dcterms:W3CDTF">2023-08-10T15:54:02Z</dcterms:created>
  <dcterms:modified xsi:type="dcterms:W3CDTF">2023-10-09T09:19:34Z</dcterms:modified>
</cp:coreProperties>
</file>